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CE824-C021-4908-9C91-684DC3D5D2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5F7C80-00C3-4B9F-A1B6-7B389A8F17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66954C-DF9F-4930-8625-10F2C1A765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CB4DB-A787-4DD0-8322-2FB5E36061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74"/>
              </a:spcBef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454D7-43FC-49F3-8761-1DA2D7633B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BAB66-5939-45CD-A22C-2E9D5264B5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78FD7-A4E5-4DE4-BFD4-718215C2AC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DBA41B-9391-4350-AFD1-AD69F4032F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74"/>
              </a:spcBef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679B99-5613-4D06-B651-56256A23DE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550AA-B2A9-411B-B15F-CAF9FFA4EB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999A7-890E-490F-A1DA-9C8DC3E82E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DAD67-C954-4E22-8F13-F930AA75ED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ctr">
            <a:noAutofit/>
          </a:bodyPr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rmAutofit/>
          </a:bodyPr>
          <a:p>
            <a:pPr marL="326880" indent="-326880">
              <a:spcBef>
                <a:spcPts val="774"/>
              </a:spcBef>
              <a:buClr>
                <a:srgbClr val="000000"/>
              </a:buClr>
              <a:buFont typeface="Arial"/>
              <a:buChar char="•"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1" marL="708120" indent="-271440">
              <a:spcBef>
                <a:spcPts val="774"/>
              </a:spcBef>
              <a:buClr>
                <a:srgbClr val="000000"/>
              </a:buClr>
              <a:buFont typeface="Arial"/>
              <a:buChar char="–"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2" marL="1090440" indent="-217440">
              <a:spcBef>
                <a:spcPts val="774"/>
              </a:spcBef>
              <a:buClr>
                <a:srgbClr val="000000"/>
              </a:buClr>
              <a:buFont typeface="Arial"/>
              <a:buChar char="•"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3" marL="1527120" indent="-217440">
              <a:spcBef>
                <a:spcPts val="774"/>
              </a:spcBef>
              <a:buClr>
                <a:srgbClr val="000000"/>
              </a:buClr>
              <a:buFont typeface="Arial"/>
              <a:buChar char="–"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4" marL="1963800" indent="-220680">
              <a:spcBef>
                <a:spcPts val="774"/>
              </a:spcBef>
              <a:buClr>
                <a:srgbClr val="000000"/>
              </a:buClr>
              <a:buFont typeface="Arial"/>
              <a:buChar char="»"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5" marL="1963800" indent="-220680">
              <a:spcBef>
                <a:spcPts val="774"/>
              </a:spcBef>
              <a:buClr>
                <a:srgbClr val="000000"/>
              </a:buClr>
              <a:buFont typeface="Arial"/>
              <a:buChar char="»"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6" marL="1963800" indent="-220680">
              <a:spcBef>
                <a:spcPts val="774"/>
              </a:spcBef>
              <a:buClr>
                <a:srgbClr val="000000"/>
              </a:buClr>
              <a:buFont typeface="Arial"/>
              <a:buChar char="»"/>
              <a:tabLst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080"/>
            <a:ext cx="1600200" cy="6332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Autofit/>
          </a:bodyPr>
          <a:lstStyle>
            <a:lvl1pPr indent="0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080"/>
            <a:ext cx="2171520" cy="6332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Autofit/>
          </a:bodyPr>
          <a:lstStyle>
            <a:lvl1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080"/>
            <a:ext cx="1600200" cy="633240"/>
          </a:xfrm>
          <a:prstGeom prst="rect">
            <a:avLst/>
          </a:prstGeom>
          <a:noFill/>
          <a:ln w="0">
            <a:noFill/>
          </a:ln>
        </p:spPr>
        <p:txBody>
          <a:bodyPr lIns="87120" rIns="87120" tIns="43560" bIns="43560" anchor="t">
            <a:noAutofit/>
          </a:bodyPr>
          <a:lstStyle>
            <a:lvl1pPr indent="0" algn="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fld id="{4A6FBAAB-F335-4196-9362-623F792CB43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20200" y="334800"/>
            <a:ext cx="316800" cy="39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7120" rIns="87120" tIns="43560" bIns="43560" anchor="t">
            <a:spAutoFit/>
          </a:bodyPr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i="1" lang="fr-FR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07600" y="2209680"/>
            <a:ext cx="316800" cy="39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7120" rIns="87120" tIns="43560" bIns="43560" anchor="t">
            <a:spAutoFit/>
          </a:bodyPr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i="1" lang="fr-FR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rcRect l="9519" t="32769" r="0" b="43298"/>
          <a:stretch/>
        </p:blipFill>
        <p:spPr>
          <a:xfrm>
            <a:off x="1000080" y="801720"/>
            <a:ext cx="3308400" cy="106056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2">
            <a:lum bright="12000"/>
          </a:blip>
          <a:srcRect l="18706" t="45151" r="18332" b="17769"/>
          <a:stretch/>
        </p:blipFill>
        <p:spPr>
          <a:xfrm>
            <a:off x="1006560" y="2728800"/>
            <a:ext cx="3297240" cy="145584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162440" y="236232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551600" y="25113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949400" y="251136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323080" y="25113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727360" y="251136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104280" y="25113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508560" y="251136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693440" y="225252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555920" y="2540160"/>
            <a:ext cx="65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471400" y="225252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070080" y="2252520"/>
            <a:ext cx="74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67 d</a:t>
            </a:r>
            <a:r>
              <a:rPr b="1" i="1" lang="fr-FR" sz="1400" spc="-1" strike="noStrike">
                <a:solidFill>
                  <a:srgbClr val="000000"/>
                </a:solidFill>
                <a:latin typeface="Arial"/>
              </a:rPr>
              <a:t>p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006560" y="2728800"/>
            <a:ext cx="3295440" cy="1454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333520" y="2540160"/>
            <a:ext cx="657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114720" y="2540160"/>
            <a:ext cx="657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3820320" y="2398680"/>
            <a:ext cx="4579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1" lang="fr-FR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553280" y="3767040"/>
            <a:ext cx="201276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400" spc="-1" strike="noStrike">
                <a:solidFill>
                  <a:srgbClr val="000000"/>
                </a:solidFill>
                <a:latin typeface="Arial"/>
              </a:rPr>
              <a:t>RSPO 1 </a:t>
            </a: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(Spondin 1/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X 30 cycl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011240" y="790560"/>
            <a:ext cx="3295800" cy="1085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846600" y="38592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175400" y="5349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751040" y="53496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277000" y="5349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795760" y="53496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335320" y="276120"/>
            <a:ext cx="74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50 d</a:t>
            </a:r>
            <a:r>
              <a:rPr b="1" i="1" lang="fr-FR" sz="1400" spc="-1" strike="noStrike">
                <a:solidFill>
                  <a:srgbClr val="000000"/>
                </a:solidFill>
                <a:latin typeface="Arial"/>
              </a:rPr>
              <a:t>p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211480" y="563400"/>
            <a:ext cx="9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3279240" y="422280"/>
            <a:ext cx="4579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1" lang="fr-FR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401120" y="2811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098720" y="568440"/>
            <a:ext cx="9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583520" y="914400"/>
            <a:ext cx="2012760" cy="80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400" spc="-1" strike="noStrike">
                <a:solidFill>
                  <a:srgbClr val="000000"/>
                </a:solidFill>
                <a:latin typeface="Arial"/>
              </a:rPr>
              <a:t>RSPO 1 </a:t>
            </a: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(Spondin 7/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Arial"/>
              </a:rPr>
              <a:t>421 b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X 35 cycl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35960" y="4614840"/>
            <a:ext cx="303120" cy="39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7120" rIns="87120" tIns="43560" bIns="43560" anchor="t">
            <a:spAutoFit/>
          </a:bodyPr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i="1" lang="fr-FR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166000" y="6842160"/>
            <a:ext cx="424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Verdana"/>
              </a:rPr>
              <a:t>X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77720" y="6851520"/>
            <a:ext cx="622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100" spc="-1" strike="noStrike">
                <a:solidFill>
                  <a:srgbClr val="000000"/>
                </a:solidFill>
                <a:latin typeface="Verdana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86000" y="6094440"/>
            <a:ext cx="60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100" spc="-1" strike="noStrike">
                <a:solidFill>
                  <a:srgbClr val="000000"/>
                </a:solidFill>
                <a:latin typeface="Verdana"/>
              </a:rPr>
              <a:t>FOXL2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166000" y="5452920"/>
            <a:ext cx="424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Verdana"/>
              </a:rPr>
              <a:t>X3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06160" y="5450040"/>
            <a:ext cx="589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100" spc="-1" strike="noStrike">
                <a:solidFill>
                  <a:srgbClr val="000000"/>
                </a:solidFill>
                <a:latin typeface="Verdana"/>
              </a:rPr>
              <a:t>RSPO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167800" y="6162840"/>
            <a:ext cx="424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Verdana"/>
              </a:rPr>
              <a:t>X3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rot="16200000">
            <a:off x="3741840" y="4877640"/>
            <a:ext cx="4921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Verdana"/>
              </a:rPr>
              <a:t>H</a:t>
            </a:r>
            <a:r>
              <a:rPr b="0" lang="fr-FR" sz="1000" spc="-1" strike="noStrike" baseline="-25000">
                <a:solidFill>
                  <a:srgbClr val="000000"/>
                </a:solidFill>
                <a:latin typeface="Verdana"/>
              </a:rPr>
              <a:t>2</a:t>
            </a:r>
            <a:r>
              <a:rPr b="0" lang="fr-FR" sz="1000" spc="-1" strike="noStrike">
                <a:solidFill>
                  <a:srgbClr val="000000"/>
                </a:solidFill>
                <a:latin typeface="Verdana"/>
              </a:rPr>
              <a:t>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720800" y="4876920"/>
            <a:ext cx="2038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738440" y="4624560"/>
            <a:ext cx="197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Verdana"/>
                <a:ea typeface="Times New Roman"/>
              </a:rPr>
              <a:t>Mesonephros 40 d</a:t>
            </a:r>
            <a:r>
              <a:rPr b="1" i="1" lang="fr-FR" sz="1100" spc="-1" strike="noStrike">
                <a:solidFill>
                  <a:srgbClr val="000000"/>
                </a:solidFill>
                <a:latin typeface="Verdana"/>
                <a:ea typeface="Times New Roman"/>
              </a:rPr>
              <a:t>p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968560" y="5191200"/>
            <a:ext cx="771480" cy="0"/>
          </a:xfrm>
          <a:prstGeom prst="line">
            <a:avLst/>
          </a:prstGeom>
          <a:ln w="9360">
            <a:solidFill>
              <a:srgbClr val="4d4d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720800" y="5191200"/>
            <a:ext cx="752400" cy="0"/>
          </a:xfrm>
          <a:prstGeom prst="line">
            <a:avLst/>
          </a:prstGeom>
          <a:ln w="9360">
            <a:solidFill>
              <a:srgbClr val="4d4d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540160" y="5191200"/>
            <a:ext cx="323640" cy="0"/>
          </a:xfrm>
          <a:prstGeom prst="line">
            <a:avLst/>
          </a:prstGeom>
          <a:ln w="9360">
            <a:solidFill>
              <a:srgbClr val="4d4d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" descr=""/>
          <p:cNvPicPr/>
          <p:nvPr/>
        </p:nvPicPr>
        <p:blipFill>
          <a:blip r:embed="rId3">
            <a:lum bright="6000"/>
          </a:blip>
          <a:srcRect l="2257" t="14281" r="24304" b="76870"/>
          <a:stretch/>
        </p:blipFill>
        <p:spPr>
          <a:xfrm>
            <a:off x="1130400" y="5276880"/>
            <a:ext cx="4029120" cy="647640"/>
          </a:xfrm>
          <a:prstGeom prst="rect">
            <a:avLst/>
          </a:prstGeom>
          <a:ln w="9360">
            <a:solidFill>
              <a:srgbClr val="808080"/>
            </a:solidFill>
            <a:miter/>
          </a:ln>
        </p:spPr>
      </p:pic>
      <p:pic>
        <p:nvPicPr>
          <p:cNvPr id="87" name="" descr=""/>
          <p:cNvPicPr/>
          <p:nvPr/>
        </p:nvPicPr>
        <p:blipFill>
          <a:blip r:embed="rId4"/>
          <a:srcRect l="13281" t="68474" r="3694" b="21526"/>
          <a:stretch/>
        </p:blipFill>
        <p:spPr>
          <a:xfrm>
            <a:off x="1130400" y="6664320"/>
            <a:ext cx="4029120" cy="647640"/>
          </a:xfrm>
          <a:prstGeom prst="rect">
            <a:avLst/>
          </a:prstGeom>
          <a:ln w="9360">
            <a:solidFill>
              <a:srgbClr val="808080"/>
            </a:solidFill>
            <a:miter/>
          </a:ln>
        </p:spPr>
      </p:pic>
      <p:sp>
        <p:nvSpPr>
          <p:cNvPr id="88" name=""/>
          <p:cNvSpPr/>
          <p:nvPr/>
        </p:nvSpPr>
        <p:spPr>
          <a:xfrm>
            <a:off x="1915560" y="4875120"/>
            <a:ext cx="31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♂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544120" y="4875120"/>
            <a:ext cx="31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♀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988720" y="4875120"/>
            <a:ext cx="53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♂ 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X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227120" y="4896000"/>
            <a:ext cx="31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♀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642920" y="4896000"/>
            <a:ext cx="31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♂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" descr=""/>
          <p:cNvPicPr/>
          <p:nvPr/>
        </p:nvPicPr>
        <p:blipFill>
          <a:blip r:embed="rId5">
            <a:lum bright="6000"/>
          </a:blip>
          <a:srcRect l="1088" t="42011" r="15290" b="30809"/>
          <a:stretch/>
        </p:blipFill>
        <p:spPr>
          <a:xfrm>
            <a:off x="1130400" y="5969160"/>
            <a:ext cx="4032000" cy="647640"/>
          </a:xfrm>
          <a:prstGeom prst="rect">
            <a:avLst/>
          </a:prstGeom>
          <a:ln w="9360">
            <a:solidFill>
              <a:srgbClr val="808080"/>
            </a:solidFill>
            <a:miter/>
          </a:ln>
        </p:spPr>
      </p:pic>
      <p:sp>
        <p:nvSpPr>
          <p:cNvPr id="94" name=""/>
          <p:cNvSpPr/>
          <p:nvPr/>
        </p:nvSpPr>
        <p:spPr>
          <a:xfrm flipV="1">
            <a:off x="4199040" y="5263920"/>
            <a:ext cx="0" cy="204444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214880" y="4881600"/>
            <a:ext cx="7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762360" y="4641840"/>
            <a:ext cx="170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Verdana"/>
                <a:ea typeface="Times New Roman"/>
              </a:rPr>
              <a:t>Gonads 70 d</a:t>
            </a:r>
            <a:r>
              <a:rPr b="1" i="1" lang="fr-FR" sz="1100" spc="-1" strike="noStrike">
                <a:solidFill>
                  <a:srgbClr val="000000"/>
                </a:solidFill>
                <a:latin typeface="Verdana"/>
                <a:ea typeface="Times New Roman"/>
              </a:rPr>
              <a:t>p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74760" y="7640640"/>
            <a:ext cx="6002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– RT-PCR analyses on goat gonads confirming 5’-RACE resul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– RT-PCR analyses on goat gonads showing the absence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SPO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ranscript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ithout exon 4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– RT-PCR analyses on goat mesonephroi show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SPO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expression in this tissu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73000"/>
                <a:tab algn="l" pos="1746360"/>
                <a:tab algn="l" pos="2619360"/>
                <a:tab algn="l" pos="3492360"/>
                <a:tab algn="l" pos="4365720"/>
                <a:tab algn="l" pos="5238720"/>
                <a:tab algn="l" pos="6111720"/>
                <a:tab algn="l" pos="6985080"/>
                <a:tab algn="l" pos="7858080"/>
                <a:tab algn="l" pos="8731080"/>
                <a:tab algn="l" pos="9604440"/>
                <a:tab algn="l" pos="104774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 = Molecular weight marker. E4 = exon 4 (TSP domain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256040" y="484344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rot="16200000">
            <a:off x="4406760" y="3403440"/>
            <a:ext cx="126720" cy="228600"/>
          </a:xfrm>
          <a:prstGeom prst="triangle">
            <a:avLst>
              <a:gd name="adj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638240" y="3414600"/>
            <a:ext cx="88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Arial"/>
              </a:rPr>
              <a:t>+E4 = 361 b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rot="16200000">
            <a:off x="4424400" y="2900160"/>
            <a:ext cx="126720" cy="228600"/>
          </a:xfrm>
          <a:prstGeom prst="triangle">
            <a:avLst>
              <a:gd name="adj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4670280" y="2911320"/>
            <a:ext cx="854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Arial"/>
              </a:rPr>
              <a:t>-E4 = 172 b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26T18:55:33Z</dcterms:created>
  <dc:creator> Maelle Pannetier</dc:creator>
  <dc:description/>
  <dc:language>en-US</dc:language>
  <cp:lastModifiedBy>Eric Pailhoux</cp:lastModifiedBy>
  <dcterms:modified xsi:type="dcterms:W3CDTF">2008-03-12T16:15:00Z</dcterms:modified>
  <cp:revision>50</cp:revision>
  <dc:subject/>
  <dc:title>Diapositive 1</dc:title>
</cp:coreProperties>
</file>